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EC00217-241C-4E7C-813D-4C40CA0FBA93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752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E4B1CA6-3ABD-4913-9A58-1E7448DFDD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584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CDDD13C-52E1-44E6-844F-9C7412AA1C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08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8440" y="182520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08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8440" y="4097520"/>
            <a:ext cx="338544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4A3D5FB-00E0-4376-BB28-7B54042C2BB2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36B1FAC-133D-43F6-A5C3-976E1C45F0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5E9F01C-16C3-4769-A4DF-F2C4568843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3529860-B29E-4AF7-BD10-F80ABB4C08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4CB4F0D-9C75-43EC-BAD9-1C96FA2B7F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4160" cy="6139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4CD842F-E3CE-44E9-ACF6-BBCA66F969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20AA91C-FA51-4EDA-A681-2920829F4E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5840" y="409752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50B9059-F05F-4055-AEFF-87F772CA32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5840" y="1825200"/>
            <a:ext cx="5130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7520"/>
            <a:ext cx="1051416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0B87D9D-AE19-4C71-B03E-0E248D0BEF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416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416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Segoe U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Segoe U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"/>
          <p:cNvSpPr/>
          <p:nvPr/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8610480" y="6356160"/>
            <a:ext cx="27417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Segoe U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03CF6AE7-33CE-46A9-B24A-14133A21F269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Segoe U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511280" y="3097080"/>
            <a:ext cx="4584600" cy="275436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7010280" y="3097080"/>
            <a:ext cx="4584960" cy="275436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1600200" y="6172200"/>
            <a:ext cx="879480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" descr=""/>
          <p:cNvPicPr/>
          <p:nvPr/>
        </p:nvPicPr>
        <p:blipFill>
          <a:blip r:embed="rId3"/>
          <a:stretch/>
        </p:blipFill>
        <p:spPr>
          <a:xfrm>
            <a:off x="7010280" y="353880"/>
            <a:ext cx="4584960" cy="275436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4"/>
          <a:stretch/>
        </p:blipFill>
        <p:spPr>
          <a:xfrm>
            <a:off x="1511280" y="328680"/>
            <a:ext cx="4584600" cy="275580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195120" y="1197000"/>
            <a:ext cx="132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rial 1 and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"/>
          <p:cNvSpPr/>
          <p:nvPr/>
        </p:nvSpPr>
        <p:spPr>
          <a:xfrm>
            <a:off x="195120" y="3940200"/>
            <a:ext cx="132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rial 3 and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"/>
          <p:cNvSpPr/>
          <p:nvPr/>
        </p:nvSpPr>
        <p:spPr>
          <a:xfrm>
            <a:off x="0" y="5715000"/>
            <a:ext cx="12193560" cy="11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  <a:tab algn="l" pos="10972800"/>
                <a:tab algn="l" pos="11430000"/>
                <a:tab algn="l" pos="118872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ry Figure 1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tion in precipitation and relative humidity experienced by diverse rice panels evaluated in field trials 1-4. Trial 1(2017), Trial 2(2018), Trial 3(2011) and Trial 4 (2013)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  <a:tab algn="l" pos="10972800"/>
                <a:tab algn="l" pos="11430000"/>
                <a:tab algn="l" pos="118872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  <a:tab algn="l" pos="10972800"/>
                <a:tab algn="l" pos="11430000"/>
                <a:tab algn="l" pos="118872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Microsoft YaHei"/>
              </a:rPr>
              <a:t>Association mapping of drought tolerance and agronomic traits in rice (Oryza sativa L.) landrace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  <a:tab algn="l" pos="10972800"/>
                <a:tab algn="l" pos="11430000"/>
                <a:tab algn="l" pos="11887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adha Beena1, @,*, Silvas Kirubakaran2*, Narayanan Nithya1*, Alagu Manickavelu3, Rameshwar Prasad Sah4, Puthenpeedikal Salim Abida5, Janardanan Sreekumar6, Poolakkal Muhammed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  <a:tab algn="l" pos="10972800"/>
                <a:tab algn="l" pos="11430000"/>
                <a:tab algn="l" pos="11887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Jaslam7, Rajendrakumar Rejeth1, Vijayalayam Gengamma Jayalekshmy8, Stephen Roy1, Ramakrishnan Vimala Manju1, Mariasoosai Mary Viji1 and Kadambot H.M. Siddique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1-20T23:19:30Z</dcterms:created>
  <dc:creator>Prince Kirubakaran, Silvas</dc:creator>
  <dc:description/>
  <dc:language>en-US</dc:language>
  <cp:lastModifiedBy/>
  <dcterms:modified xsi:type="dcterms:W3CDTF">2021-09-01T01:45:08Z</dcterms:modified>
  <cp:revision>5</cp:revision>
  <dc:subject/>
  <dc:title>PowerPoint Presentation</dc:title>
</cp:coreProperties>
</file>